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2">
  <p:sldMasterIdLst>
    <p:sldMasterId id="2147483648" r:id="rId1"/>
  </p:sldMasterIdLst>
  <p:sldIdLst>
    <p:sldId id="309" r:id="rId2"/>
    <p:sldId id="326" r:id="rId3"/>
    <p:sldId id="327" r:id="rId4"/>
    <p:sldId id="328" r:id="rId5"/>
    <p:sldId id="313" r:id="rId6"/>
    <p:sldId id="324" r:id="rId7"/>
    <p:sldId id="318" r:id="rId8"/>
    <p:sldId id="320" r:id="rId9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3B4B98B0-60AC-42C2-AFA5-B58CD77FA1E5}" styleName="浅色样式 1 - 强调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014" autoAdjust="0"/>
    <p:restoredTop sz="94660"/>
  </p:normalViewPr>
  <p:slideViewPr>
    <p:cSldViewPr snapToGrid="0">
      <p:cViewPr varScale="1">
        <p:scale>
          <a:sx n="110" d="100"/>
          <a:sy n="110" d="100"/>
        </p:scale>
        <p:origin x="570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483506B-383F-47BE-8CE2-9F4B8B4AD51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3721907-57C1-660C-45E0-9F0480F2524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E1A2026-CCF1-3D75-CE29-7775A36AED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2C1378-A4AA-45EC-AF35-4882CC84DBBB}" type="datetimeFigureOut">
              <a:rPr lang="en-US" smtClean="0"/>
              <a:t>4/17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2005CE4-D9F5-EA12-5A36-F99F4E90C4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7DA7A21-6EEA-835C-0ADE-3F6C99B884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B650C7-22D3-4583-806E-7676E02650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1687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67635CE-70B5-B4CB-779B-5651F41B795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CC30483-5F5E-E7C6-29E9-5B369910D1C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272D47C-2036-886D-CDAE-1788EFC561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2C1378-A4AA-45EC-AF35-4882CC84DBBB}" type="datetimeFigureOut">
              <a:rPr lang="en-US" smtClean="0"/>
              <a:t>4/17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F7308D4-F241-2518-64F8-CB81556361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2882D69-3AFA-2225-3D19-598999EAA4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B650C7-22D3-4583-806E-7676E02650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30805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E3E6380-E00B-172A-65A8-91E2BFB70DF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ECD90EB-2ECD-F6FB-AF99-1C6D8D31A8D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2718C59-CEBE-1953-7D5E-4F17816042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2C1378-A4AA-45EC-AF35-4882CC84DBBB}" type="datetimeFigureOut">
              <a:rPr lang="en-US" smtClean="0"/>
              <a:t>4/17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9C2875A-3DF3-1895-F764-E9CE9F7BBD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661B245-9A5B-F6F6-1001-0F6B2B579A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B650C7-22D3-4583-806E-7676E02650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67381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B0EEA62-F32D-3EB8-3BDA-4CD901D3B01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7FD0C81-2B28-BB33-927D-63CD9D5C16D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06AA5DB-8BFB-F73B-D838-CED760ACE7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2C1378-A4AA-45EC-AF35-4882CC84DBBB}" type="datetimeFigureOut">
              <a:rPr lang="en-US" smtClean="0"/>
              <a:t>4/17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9BA2F65-5334-5657-5671-21E6302B2B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007F2F0-40F2-2143-FE8E-431FD1E0B8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B650C7-22D3-4583-806E-7676E02650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18269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EED0E0F-AA40-C505-6F97-B655C56993E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627D3B7-82C1-2CE9-ADA4-8AF0AB88239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F090753-24F4-88DE-5C4B-A63D0CE877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2C1378-A4AA-45EC-AF35-4882CC84DBBB}" type="datetimeFigureOut">
              <a:rPr lang="en-US" smtClean="0"/>
              <a:t>4/17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719F667-5FCD-D091-AD64-AAF8F099A5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34B0BA7-B6A8-4775-AFD5-375DC91E6D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B650C7-22D3-4583-806E-7676E02650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10130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8F29FF9-8D61-A526-1838-9684F499B28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ADA75C6-5DD1-44D3-FCD9-CF99E69D746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9E5B377-8CF5-F0A5-B920-1B57FC2D355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572FD78-4F32-81E0-0898-2431468A05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2C1378-A4AA-45EC-AF35-4882CC84DBBB}" type="datetimeFigureOut">
              <a:rPr lang="en-US" smtClean="0"/>
              <a:t>4/17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6428D6C-BC42-DB18-E7DA-BB66540DD9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33B0CBF-EC90-2905-9C2E-7B6D9478E4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B650C7-22D3-4583-806E-7676E02650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99760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A082F51-EDAA-CCFB-ACFC-DEE7C1BEFD0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412239C-687A-6229-6AAF-9F0AF256EB9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AE80A00-9A0F-987D-ECDD-386EBB3AF79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418E06F-F6BD-F650-3CC5-C8CEDC6C639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7465748-F678-B41D-E4A3-112FBEEB05F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9A2852F-2AF7-8AD8-C59F-5F59588561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2C1378-A4AA-45EC-AF35-4882CC84DBBB}" type="datetimeFigureOut">
              <a:rPr lang="en-US" smtClean="0"/>
              <a:t>4/17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A9090A2-C770-DA78-557F-578002A6EE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7488BC7-D7A9-4CB3-D853-D3B778FA77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B650C7-22D3-4583-806E-7676E02650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35207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262BEE9-75D6-2936-E306-0320DCB04F7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486DFE3-5D17-A24B-2191-7C23F2D9DF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2C1378-A4AA-45EC-AF35-4882CC84DBBB}" type="datetimeFigureOut">
              <a:rPr lang="en-US" smtClean="0"/>
              <a:t>4/17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50659BA-66EC-3AC6-18C7-E96814F7D5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82BD710-B153-BB18-DE2C-D4195FBDF9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B650C7-22D3-4583-806E-7676E02650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10887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A719D3F-0365-D991-13B9-18FA556D39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2C1378-A4AA-45EC-AF35-4882CC84DBBB}" type="datetimeFigureOut">
              <a:rPr lang="en-US" smtClean="0"/>
              <a:t>4/17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149375D-A971-96FA-16E0-05A736CAE3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B57D2CC-0C93-AE5F-38ED-45E33F7C71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B650C7-22D3-4583-806E-7676E02650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36053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C3819B6-CB5B-586D-3F3E-782CE8927ED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CFB4877-7FEB-F20C-1A73-6B4979F6974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81695F8-0799-E41F-912E-DBDCABA0F88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ADC4B7E-3D5F-B1E0-D6B0-668400443C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2C1378-A4AA-45EC-AF35-4882CC84DBBB}" type="datetimeFigureOut">
              <a:rPr lang="en-US" smtClean="0"/>
              <a:t>4/17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1A4E175-4C75-9301-C124-88FE80CC33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EB623F2-F0F6-A201-29AD-E2B6E61461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B650C7-22D3-4583-806E-7676E02650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95745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9ED7732-F675-FA76-EE4C-E635302AB82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C8543A9-E988-C1D0-439F-414EA79C0E9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5891231-B5CE-26E1-0F56-86573E34486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29C50D1-5247-CFAF-0CC3-045516FF40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2C1378-A4AA-45EC-AF35-4882CC84DBBB}" type="datetimeFigureOut">
              <a:rPr lang="en-US" smtClean="0"/>
              <a:t>4/17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8799BFA-08A5-5B42-193F-ED702DCDE7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604F66E-1913-F00A-9C86-B239813B9C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B650C7-22D3-4583-806E-7676E02650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31360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83AFC84-8CBE-A82F-E14B-717F35B5A9B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3B00B0F-F814-8714-11DF-EA642B87772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91A1F98-9B0D-2196-8343-C6AF4597903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22C1378-A4AA-45EC-AF35-4882CC84DBBB}" type="datetimeFigureOut">
              <a:rPr lang="en-US" smtClean="0"/>
              <a:t>4/17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4519FBB-922E-7716-DB15-8A934D1E0CA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BAF7831-E4E6-2661-2463-DA2A3D24621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0B650C7-22D3-4583-806E-7676E02650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75338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A1C440FD-0E18-3D65-9B7A-CEE09E32DC86}"/>
              </a:ext>
            </a:extLst>
          </p:cNvPr>
          <p:cNvSpPr txBox="1"/>
          <p:nvPr/>
        </p:nvSpPr>
        <p:spPr>
          <a:xfrm>
            <a:off x="1291962" y="158283"/>
            <a:ext cx="7812157" cy="830996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ELETRONIC SUPPLEMENTARY FILE</a:t>
            </a:r>
          </a:p>
          <a:p>
            <a:endParaRPr lang="en-US" sz="1100" dirty="0"/>
          </a:p>
          <a:p>
            <a:pPr marL="0" marR="0" algn="just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200" kern="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ordia New" panose="020B0304020202020204" pitchFamily="34" charset="-34"/>
              </a:rPr>
              <a:t>The novel phenotype “major neurocognitive psychosis” is validated as a distinct class through the analysis of immune-linked neurotoxicity biomarkers and cognitive deficits.</a:t>
            </a:r>
            <a:endParaRPr lang="en-US" sz="12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Cordia New" panose="020B0304020202020204" pitchFamily="34" charset="-34"/>
            </a:endParaRPr>
          </a:p>
          <a:p>
            <a:pPr marL="0" marR="0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100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Cordia New" panose="020B0304020202020204" pitchFamily="34" charset="-34"/>
              </a:rPr>
              <a:t> </a:t>
            </a:r>
            <a:endParaRPr lang="en-US" sz="11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Cordia New" panose="020B0304020202020204" pitchFamily="34" charset="-34"/>
            </a:endParaRPr>
          </a:p>
          <a:p>
            <a:pPr marL="0" marR="0" algn="just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100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Cordia New" panose="020B0304020202020204" pitchFamily="34" charset="-34"/>
              </a:rPr>
              <a:t>(1) Petar Popov, (2,3) C</a:t>
            </a:r>
            <a:r>
              <a:rPr lang="en-US" altLang="zh-CN" sz="1100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Cordia New" panose="020B0304020202020204" pitchFamily="34" charset="-34"/>
              </a:rPr>
              <a:t>hen </a:t>
            </a:r>
            <a:r>
              <a:rPr lang="en-US" altLang="zh-CN" sz="1100" kern="100" dirty="0" err="1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Cordia New" panose="020B0304020202020204" pitchFamily="34" charset="-34"/>
              </a:rPr>
              <a:t>Chen</a:t>
            </a:r>
            <a:r>
              <a:rPr lang="en-US" sz="1100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Cordia New" panose="020B0304020202020204" pitchFamily="34" charset="-34"/>
              </a:rPr>
              <a:t>,</a:t>
            </a:r>
            <a:r>
              <a:rPr lang="en-US" sz="1100" kern="100" dirty="0">
                <a:effectLst/>
                <a:latin typeface="Times New Roman" panose="02020603050405020304" pitchFamily="18" charset="0"/>
                <a:ea typeface="CharisSIL"/>
                <a:cs typeface="Cordia New" panose="020B0304020202020204" pitchFamily="34" charset="-34"/>
              </a:rPr>
              <a:t> (4) Hussein Kadhem Al-Hakeim, (5) Ali Fattah Al-Musawi, (6) </a:t>
            </a:r>
            <a:r>
              <a:rPr lang="en-US" sz="1100" kern="100" dirty="0">
                <a:effectLst/>
                <a:latin typeface="Times New Roman" panose="02020603050405020304" pitchFamily="18" charset="0"/>
                <a:ea typeface="CIDFont+F2"/>
                <a:cs typeface="Cordia New" panose="020B0304020202020204" pitchFamily="34" charset="-34"/>
              </a:rPr>
              <a:t>Arafat Hussein Al-</a:t>
            </a:r>
            <a:r>
              <a:rPr lang="en-US" sz="1100" kern="100" dirty="0" err="1">
                <a:effectLst/>
                <a:latin typeface="Times New Roman" panose="02020603050405020304" pitchFamily="18" charset="0"/>
                <a:ea typeface="CIDFont+F2"/>
                <a:cs typeface="Cordia New" panose="020B0304020202020204" pitchFamily="34" charset="-34"/>
              </a:rPr>
              <a:t>Dujaili</a:t>
            </a:r>
            <a:r>
              <a:rPr lang="en-US" sz="1100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Cordia New" panose="020B0304020202020204" pitchFamily="34" charset="-34"/>
              </a:rPr>
              <a:t>, (1,7,8) Drozdstoy Stoyanov, (1,2,3,7,8,9,10) </a:t>
            </a:r>
            <a:r>
              <a:rPr lang="en-US" sz="1100" kern="100" dirty="0">
                <a:effectLst/>
                <a:latin typeface="Times New Roman" panose="02020603050405020304" pitchFamily="18" charset="0"/>
                <a:ea typeface="CharisSIL"/>
                <a:cs typeface="Cordia New" panose="020B0304020202020204" pitchFamily="34" charset="-34"/>
              </a:rPr>
              <a:t>Michael Maes</a:t>
            </a:r>
            <a:endParaRPr lang="en-US" sz="11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Cordia New" panose="020B0304020202020204" pitchFamily="34" charset="-34"/>
            </a:endParaRPr>
          </a:p>
          <a:p>
            <a:pPr marL="0" marR="0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100" b="1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 </a:t>
            </a:r>
            <a:endParaRPr lang="en-US" sz="1100" dirty="0">
              <a:solidFill>
                <a:srgbClr val="000000"/>
              </a:solidFill>
              <a:effectLst/>
              <a:latin typeface="Times New Roman" panose="02020603050405020304" pitchFamily="18" charset="0"/>
              <a:ea typeface="Calibri" panose="020F0502020204030204" pitchFamily="34" charset="0"/>
            </a:endParaRPr>
          </a:p>
          <a:p>
            <a:pPr marL="0" marR="0" algn="just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100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Cordia New" panose="020B0304020202020204" pitchFamily="34" charset="-34"/>
              </a:rPr>
              <a:t>(1) Department of Psychiatry, Medical University of Plovdiv, Plovdiv, Bulgaria.</a:t>
            </a:r>
            <a:endParaRPr lang="en-US" sz="11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Cordia New" panose="020B0304020202020204" pitchFamily="34" charset="-34"/>
            </a:endParaRPr>
          </a:p>
          <a:p>
            <a:pPr marL="0" marR="0" algn="just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100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Cordia New" panose="020B0304020202020204" pitchFamily="34" charset="-34"/>
              </a:rPr>
              <a:t>(2) </a:t>
            </a:r>
            <a:r>
              <a:rPr lang="en-US" sz="1100" kern="1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Cordia New" panose="020B0304020202020204" pitchFamily="34" charset="-34"/>
              </a:rPr>
              <a:t>Sichuan Provincial Center for Mental Health, Sichuan Provincial People’s Hospital, School of Medicine, University of Electronic Science and Technology of China, Chengdu 610072, China</a:t>
            </a:r>
            <a:endParaRPr lang="en-US" sz="11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Cordia New" panose="020B0304020202020204" pitchFamily="34" charset="-34"/>
            </a:endParaRPr>
          </a:p>
          <a:p>
            <a:pPr marL="0" marR="0" algn="just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100" kern="1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Cordia New" panose="020B0304020202020204" pitchFamily="34" charset="-34"/>
              </a:rPr>
              <a:t>(3) Key Laboratory of Psychosomatic Medicine, Chinese Academy of Medical Sciences, Chengdu, 610072, China</a:t>
            </a:r>
            <a:endParaRPr lang="en-US" sz="11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Cordia New" panose="020B0304020202020204" pitchFamily="34" charset="-34"/>
            </a:endParaRPr>
          </a:p>
          <a:p>
            <a:pPr marL="0" marR="0" algn="just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100" kern="100" dirty="0">
                <a:effectLst/>
                <a:latin typeface="Times New Roman" panose="02020603050405020304" pitchFamily="18" charset="0"/>
                <a:ea typeface="CharisSIL"/>
                <a:cs typeface="Cordia New" panose="020B0304020202020204" pitchFamily="34" charset="-34"/>
              </a:rPr>
              <a:t>(4) Department of Chemistry, College of Science, University of Kufa, Iraq.</a:t>
            </a:r>
            <a:endParaRPr lang="en-US" sz="11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Cordia New" panose="020B0304020202020204" pitchFamily="34" charset="-34"/>
            </a:endParaRPr>
          </a:p>
          <a:p>
            <a:pPr marL="0" marR="0" algn="just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100" kern="100" dirty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Times New Roman" panose="02020603050405020304" pitchFamily="18" charset="0"/>
                <a:ea typeface="CharisSIL"/>
                <a:cs typeface="Cordia New" panose="020B0304020202020204" pitchFamily="34" charset="-34"/>
              </a:rPr>
              <a:t>(5) Department of Clinical Pharmacy and Laboratory Sciences, College of Pharmacy, University of Al-</a:t>
            </a:r>
            <a:r>
              <a:rPr lang="en-US" sz="1100" kern="100" dirty="0" err="1">
                <a:solidFill>
                  <a:srgbClr val="000000"/>
                </a:solidFill>
                <a:effectLst/>
                <a:highlight>
                  <a:srgbClr val="FFFFFF"/>
                </a:highlight>
                <a:latin typeface="Times New Roman" panose="02020603050405020304" pitchFamily="18" charset="0"/>
                <a:ea typeface="CharisSIL"/>
                <a:cs typeface="Cordia New" panose="020B0304020202020204" pitchFamily="34" charset="-34"/>
              </a:rPr>
              <a:t>Kafeel</a:t>
            </a:r>
            <a:r>
              <a:rPr lang="en-US" sz="1100" kern="100" dirty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Times New Roman" panose="02020603050405020304" pitchFamily="18" charset="0"/>
                <a:ea typeface="CharisSIL"/>
                <a:cs typeface="Cordia New" panose="020B0304020202020204" pitchFamily="34" charset="-34"/>
              </a:rPr>
              <a:t>, Najaf, Iraq.</a:t>
            </a:r>
            <a:endParaRPr lang="en-US" sz="1100" kern="100" dirty="0">
              <a:effectLst/>
              <a:highlight>
                <a:srgbClr val="FFFFFF"/>
              </a:highlight>
              <a:latin typeface="Calibri" panose="020F0502020204030204" pitchFamily="34" charset="0"/>
              <a:ea typeface="DengXian" panose="02010600030101010101" pitchFamily="2" charset="-122"/>
              <a:cs typeface="Cordia New" panose="020B0304020202020204" pitchFamily="34" charset="-34"/>
            </a:endParaRPr>
          </a:p>
          <a:p>
            <a:pPr marL="0" marR="0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100" kern="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ordia New" panose="020B0304020202020204" pitchFamily="34" charset="-34"/>
              </a:rPr>
              <a:t>(6) </a:t>
            </a:r>
            <a:r>
              <a:rPr lang="en-US" sz="1100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Cordia New" panose="020B0304020202020204" pitchFamily="34" charset="-34"/>
              </a:rPr>
              <a:t>Department of Psychiatry,</a:t>
            </a:r>
            <a:r>
              <a:rPr lang="en-US" sz="1100" kern="100" dirty="0">
                <a:effectLst/>
                <a:latin typeface="Times New Roman" panose="02020603050405020304" pitchFamily="18" charset="0"/>
                <a:ea typeface="CIDFont+F2"/>
                <a:cs typeface="Cordia New" panose="020B0304020202020204" pitchFamily="34" charset="-34"/>
              </a:rPr>
              <a:t> Faculty of Medicine, University of Kufa, Najaf, Iraq. </a:t>
            </a:r>
            <a:endParaRPr lang="en-US" sz="11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Cordia New" panose="020B0304020202020204" pitchFamily="34" charset="-34"/>
            </a:endParaRPr>
          </a:p>
          <a:p>
            <a:pPr marL="0" marR="0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100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Cordia New" panose="020B0304020202020204" pitchFamily="34" charset="-34"/>
              </a:rPr>
              <a:t>(7) Research Institute, Medical University Plovdiv, Plovdiv, Bulgaria</a:t>
            </a:r>
            <a:endParaRPr lang="en-US" sz="11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Cordia New" panose="020B0304020202020204" pitchFamily="34" charset="-34"/>
            </a:endParaRPr>
          </a:p>
          <a:p>
            <a:pPr marL="0" marR="0" algn="just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100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Cordia New" panose="020B0304020202020204" pitchFamily="34" charset="-34"/>
              </a:rPr>
              <a:t>(8) Research and Innovation Program for the Development of MU - PLOVDIV–(SRIPD-MUP)“, Creation of a network of research higher schools, National plan for recovery and sustainability, European Union – </a:t>
            </a:r>
            <a:r>
              <a:rPr lang="en-US" sz="1100" kern="100" dirty="0" err="1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Cordia New" panose="020B0304020202020204" pitchFamily="34" charset="-34"/>
              </a:rPr>
              <a:t>NextGenerationEU</a:t>
            </a:r>
            <a:r>
              <a:rPr lang="en-US" sz="1100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Cordia New" panose="020B0304020202020204" pitchFamily="34" charset="-34"/>
              </a:rPr>
              <a:t>.</a:t>
            </a:r>
            <a:endParaRPr lang="en-US" sz="11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Cordia New" panose="020B0304020202020204" pitchFamily="34" charset="-34"/>
            </a:endParaRPr>
          </a:p>
          <a:p>
            <a:pPr marL="0" marR="0" algn="just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100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Cordia New" panose="020B0304020202020204" pitchFamily="34" charset="-34"/>
              </a:rPr>
              <a:t>(9) Department of Psychiatry, Faculty of Medicine, Chulalongkorn University, Bangkok, Thailand</a:t>
            </a:r>
            <a:endParaRPr lang="en-US" sz="11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Cordia New" panose="020B0304020202020204" pitchFamily="34" charset="-34"/>
            </a:endParaRPr>
          </a:p>
          <a:p>
            <a:pPr marL="0" marR="0" algn="just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100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Cordia New" panose="020B0304020202020204" pitchFamily="34" charset="-34"/>
              </a:rPr>
              <a:t>(10) Kyung </a:t>
            </a:r>
            <a:r>
              <a:rPr lang="en-US" sz="1100" kern="100" dirty="0" err="1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Cordia New" panose="020B0304020202020204" pitchFamily="34" charset="-34"/>
              </a:rPr>
              <a:t>Hee</a:t>
            </a:r>
            <a:r>
              <a:rPr lang="en-US" sz="1100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Cordia New" panose="020B0304020202020204" pitchFamily="34" charset="-34"/>
              </a:rPr>
              <a:t> University, 26 </a:t>
            </a:r>
            <a:r>
              <a:rPr lang="en-US" sz="1100" kern="100" dirty="0" err="1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Cordia New" panose="020B0304020202020204" pitchFamily="34" charset="-34"/>
              </a:rPr>
              <a:t>Kyungheedae-ro</a:t>
            </a:r>
            <a:r>
              <a:rPr lang="en-US" sz="1100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Cordia New" panose="020B0304020202020204" pitchFamily="34" charset="-34"/>
              </a:rPr>
              <a:t>, Dongdaemun-</a:t>
            </a:r>
            <a:r>
              <a:rPr lang="en-US" sz="1100" kern="100" dirty="0" err="1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Cordia New" panose="020B0304020202020204" pitchFamily="34" charset="-34"/>
              </a:rPr>
              <a:t>gu</a:t>
            </a:r>
            <a:r>
              <a:rPr lang="en-US" sz="1100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Cordia New" panose="020B0304020202020204" pitchFamily="34" charset="-34"/>
              </a:rPr>
              <a:t>, Seoul 02447, Korea</a:t>
            </a:r>
            <a:endParaRPr lang="en-US" sz="11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Cordia New" panose="020B0304020202020204" pitchFamily="34" charset="-34"/>
            </a:endParaRPr>
          </a:p>
          <a:p>
            <a:endParaRPr lang="en-US" sz="1100" dirty="0"/>
          </a:p>
          <a:p>
            <a:endParaRPr lang="en-US" sz="3200" dirty="0"/>
          </a:p>
          <a:p>
            <a:endParaRPr lang="en-US" sz="3200" dirty="0"/>
          </a:p>
          <a:p>
            <a:endParaRPr lang="en-US" sz="3200" dirty="0"/>
          </a:p>
        </p:txBody>
      </p:sp>
    </p:spTree>
    <p:extLst>
      <p:ext uri="{BB962C8B-B14F-4D97-AF65-F5344CB8AC3E}">
        <p14:creationId xmlns:p14="http://schemas.microsoft.com/office/powerpoint/2010/main" val="41529542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1">
            <a:extLst>
              <a:ext uri="{FF2B5EF4-FFF2-40B4-BE49-F238E27FC236}">
                <a16:creationId xmlns:a16="http://schemas.microsoft.com/office/drawing/2014/main" id="{7EA5B57B-0413-4DFF-D12B-DED9331DCBC2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2304" y="232657"/>
            <a:ext cx="9825767" cy="5847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4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ESF, Table 1</a:t>
            </a:r>
            <a:r>
              <a:rPr kumimoji="0" lang="en-US" altLang="zh-CN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.  Demographic and clinical data in simple (SNP) and major neurocognitive psychosis (MNP) and healthy controls (HC).</a:t>
            </a:r>
            <a:endParaRPr kumimoji="0" lang="en-US" altLang="zh-CN" sz="14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GB" altLang="zh-CN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9B7CDA79-8404-2B08-0353-CC8B95D5F44A}"/>
              </a:ext>
            </a:extLst>
          </p:cNvPr>
          <p:cNvSpPr txBox="1"/>
          <p:nvPr/>
        </p:nvSpPr>
        <p:spPr>
          <a:xfrm>
            <a:off x="695047" y="5930279"/>
            <a:ext cx="10801905" cy="6001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Results are shown as mean (SD) or as prevalences or ratios. F; analysis of variance; </a:t>
            </a:r>
            <a:r>
              <a:rPr kumimoji="0" lang="en-US" altLang="zh-CN" sz="11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χ2: </a:t>
            </a:r>
            <a:r>
              <a:rPr kumimoji="0" lang="en-US" altLang="zh-CN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analysis of contingency; KWT: Kruskal Wallis test.</a:t>
            </a:r>
            <a:endParaRPr kumimoji="0" lang="en-US" altLang="zh-CN" sz="11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MR: Psychomotor retardation, FTD: formal thought disorders, BPRS: Brief Psychiatric Rating Scale, HAM-D: Hamilton Depression rating Scale, PANSS</a:t>
            </a:r>
            <a:endParaRPr kumimoji="0" lang="en-US" altLang="zh-CN" sz="11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zh-CN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ositive and Negative Syndrome Scale, </a:t>
            </a:r>
            <a:r>
              <a:rPr kumimoji="0" lang="en-US" altLang="zh-CN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ANS: </a:t>
            </a:r>
            <a:r>
              <a:rPr kumimoji="0" lang="en-GB" altLang="zh-CN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cale for the Assessments of Negative Symptoms.</a:t>
            </a:r>
            <a:endParaRPr kumimoji="0" lang="en-GB" altLang="zh-CN" sz="11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graphicFrame>
        <p:nvGraphicFramePr>
          <p:cNvPr id="6" name="表格 5">
            <a:extLst>
              <a:ext uri="{FF2B5EF4-FFF2-40B4-BE49-F238E27FC236}">
                <a16:creationId xmlns:a16="http://schemas.microsoft.com/office/drawing/2014/main" id="{ECCD3D6C-87FD-77CE-8895-F3CFD12AE7E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11004295"/>
              </p:ext>
            </p:extLst>
          </p:nvPr>
        </p:nvGraphicFramePr>
        <p:xfrm>
          <a:off x="754032" y="745720"/>
          <a:ext cx="8753953" cy="5103401"/>
        </p:xfrm>
        <a:graphic>
          <a:graphicData uri="http://schemas.openxmlformats.org/drawingml/2006/table">
            <a:tbl>
              <a:tblPr firstRow="1" firstCol="1" bandRow="1"/>
              <a:tblGrid>
                <a:gridCol w="1784589">
                  <a:extLst>
                    <a:ext uri="{9D8B030D-6E8A-4147-A177-3AD203B41FA5}">
                      <a16:colId xmlns:a16="http://schemas.microsoft.com/office/drawing/2014/main" val="2052652843"/>
                    </a:ext>
                  </a:extLst>
                </a:gridCol>
                <a:gridCol w="1251736">
                  <a:extLst>
                    <a:ext uri="{9D8B030D-6E8A-4147-A177-3AD203B41FA5}">
                      <a16:colId xmlns:a16="http://schemas.microsoft.com/office/drawing/2014/main" val="121007818"/>
                    </a:ext>
                  </a:extLst>
                </a:gridCol>
                <a:gridCol w="1251736">
                  <a:extLst>
                    <a:ext uri="{9D8B030D-6E8A-4147-A177-3AD203B41FA5}">
                      <a16:colId xmlns:a16="http://schemas.microsoft.com/office/drawing/2014/main" val="926542077"/>
                    </a:ext>
                  </a:extLst>
                </a:gridCol>
                <a:gridCol w="1251736">
                  <a:extLst>
                    <a:ext uri="{9D8B030D-6E8A-4147-A177-3AD203B41FA5}">
                      <a16:colId xmlns:a16="http://schemas.microsoft.com/office/drawing/2014/main" val="1179278434"/>
                    </a:ext>
                  </a:extLst>
                </a:gridCol>
                <a:gridCol w="1162192">
                  <a:extLst>
                    <a:ext uri="{9D8B030D-6E8A-4147-A177-3AD203B41FA5}">
                      <a16:colId xmlns:a16="http://schemas.microsoft.com/office/drawing/2014/main" val="4116961620"/>
                    </a:ext>
                  </a:extLst>
                </a:gridCol>
                <a:gridCol w="983101">
                  <a:extLst>
                    <a:ext uri="{9D8B030D-6E8A-4147-A177-3AD203B41FA5}">
                      <a16:colId xmlns:a16="http://schemas.microsoft.com/office/drawing/2014/main" val="2668531316"/>
                    </a:ext>
                  </a:extLst>
                </a:gridCol>
                <a:gridCol w="1068863">
                  <a:extLst>
                    <a:ext uri="{9D8B030D-6E8A-4147-A177-3AD203B41FA5}">
                      <a16:colId xmlns:a16="http://schemas.microsoft.com/office/drawing/2014/main" val="289824342"/>
                    </a:ext>
                  </a:extLst>
                </a:gridCol>
              </a:tblGrid>
              <a:tr h="221887">
                <a:tc rowSpan="2"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b="1" kern="100">
                          <a:solidFill>
                            <a:srgbClr val="000000"/>
                          </a:solidFill>
                          <a:effectLst/>
                          <a:highlight>
                            <a:srgbClr val="E8E8E8"/>
                          </a:highlight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Variables</a:t>
                      </a:r>
                      <a:endParaRPr lang="zh-CN" sz="900" kern="100">
                        <a:effectLst/>
                        <a:highlight>
                          <a:srgbClr val="E8E8E8"/>
                        </a:highlight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8E8E8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b="1" kern="100">
                          <a:solidFill>
                            <a:srgbClr val="000000"/>
                          </a:solidFill>
                          <a:effectLst/>
                          <a:highlight>
                            <a:srgbClr val="E8E8E8"/>
                          </a:highlight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HC a</a:t>
                      </a:r>
                      <a:endParaRPr lang="zh-CN" sz="900" kern="100">
                        <a:effectLst/>
                        <a:highlight>
                          <a:srgbClr val="E8E8E8"/>
                        </a:highlight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8E8E8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b="1" kern="100">
                          <a:solidFill>
                            <a:srgbClr val="000000"/>
                          </a:solidFill>
                          <a:effectLst/>
                          <a:highlight>
                            <a:srgbClr val="E8E8E8"/>
                          </a:highlight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SNP b</a:t>
                      </a:r>
                      <a:endParaRPr lang="zh-CN" sz="900" kern="100">
                        <a:effectLst/>
                        <a:highlight>
                          <a:srgbClr val="E8E8E8"/>
                        </a:highlight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8E8E8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b="1" kern="100">
                          <a:solidFill>
                            <a:srgbClr val="000000"/>
                          </a:solidFill>
                          <a:effectLst/>
                          <a:highlight>
                            <a:srgbClr val="E8E8E8"/>
                          </a:highlight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MNP c</a:t>
                      </a:r>
                      <a:endParaRPr lang="zh-CN" sz="900" kern="100">
                        <a:effectLst/>
                        <a:highlight>
                          <a:srgbClr val="E8E8E8"/>
                        </a:highlight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8E8E8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b="1" kern="100">
                          <a:solidFill>
                            <a:srgbClr val="000000"/>
                          </a:solidFill>
                          <a:effectLst/>
                          <a:highlight>
                            <a:srgbClr val="E8E8E8"/>
                          </a:highlight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F/ χ2</a:t>
                      </a:r>
                      <a:endParaRPr lang="zh-CN" sz="900" kern="100">
                        <a:effectLst/>
                        <a:highlight>
                          <a:srgbClr val="E8E8E8"/>
                        </a:highlight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8E8E8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b="1" kern="100" dirty="0" err="1">
                          <a:solidFill>
                            <a:srgbClr val="000000"/>
                          </a:solidFill>
                          <a:effectLst/>
                          <a:highlight>
                            <a:srgbClr val="E8E8E8"/>
                          </a:highlight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df</a:t>
                      </a:r>
                      <a:endParaRPr lang="zh-CN" sz="900" kern="100" dirty="0">
                        <a:effectLst/>
                        <a:highlight>
                          <a:srgbClr val="E8E8E8"/>
                        </a:highlight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8E8E8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b="1" kern="100">
                          <a:solidFill>
                            <a:srgbClr val="000000"/>
                          </a:solidFill>
                          <a:effectLst/>
                          <a:highlight>
                            <a:srgbClr val="E8E8E8"/>
                          </a:highlight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P-value</a:t>
                      </a:r>
                      <a:endParaRPr lang="zh-CN" sz="900" kern="100">
                        <a:effectLst/>
                        <a:highlight>
                          <a:srgbClr val="E8E8E8"/>
                        </a:highlight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8E8E8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57658000"/>
                  </a:ext>
                </a:extLst>
              </a:tr>
              <a:tr h="221887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(n= 40)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(n= 45)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(n= 45)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86753886"/>
                  </a:ext>
                </a:extLst>
              </a:tr>
              <a:tr h="221887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Age (years)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36.78 (11.97)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37.36 (12.64)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37.49 (14.28)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0.035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2/127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0.965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6481288"/>
                  </a:ext>
                </a:extLst>
              </a:tr>
              <a:tr h="221887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Sex (Female/Male)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20/20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18/27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19/26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0.934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2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0.627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93307241"/>
                  </a:ext>
                </a:extLst>
              </a:tr>
              <a:tr h="221887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Single/married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17/23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19/26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19/26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0.001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2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1.000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18981153"/>
                  </a:ext>
                </a:extLst>
              </a:tr>
              <a:tr h="221887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BMI (kg/m</a:t>
                      </a:r>
                      <a:r>
                        <a:rPr lang="en-US" sz="900" kern="100" baseline="300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2</a:t>
                      </a: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)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26.87 (3.57)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26.86 (3.92)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27.17 (3.81)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0.097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2/127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0.908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99187520"/>
                  </a:ext>
                </a:extLst>
              </a:tr>
              <a:tr h="221887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Smoking (No/Yes)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24/16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26/19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27/18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0.06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2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0.970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97353525"/>
                  </a:ext>
                </a:extLst>
              </a:tr>
              <a:tr h="221887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Residency (Urban/Rural)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16/24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17/28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17/28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0.058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2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0.972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30456992"/>
                  </a:ext>
                </a:extLst>
              </a:tr>
              <a:tr h="221887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Employment (No/Yes)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14/26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16/29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20/25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5.33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2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0.255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96088324"/>
                  </a:ext>
                </a:extLst>
              </a:tr>
              <a:tr h="221887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Education (years)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12.08 (3.29)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9.16 (3.64)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9.49 (3.50)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8.72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2/127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&lt;0.0001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98645446"/>
                  </a:ext>
                </a:extLst>
              </a:tr>
              <a:tr h="221887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Duration of Disease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-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8.91 (7.95)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11.29 (8.44)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1.89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1/88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0.172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45100620"/>
                  </a:ext>
                </a:extLst>
              </a:tr>
              <a:tr h="221887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Family history (No/Yes) 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40/0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29/16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23/22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25.80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2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&lt;0.001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15942654"/>
                  </a:ext>
                </a:extLst>
              </a:tr>
              <a:tr h="221887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Psychosis (z score) 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-1.108 (0.134)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-0.126 (0.455)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1.111 (0.559)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KWT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-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&lt;0.0001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54496744"/>
                  </a:ext>
                </a:extLst>
              </a:tr>
              <a:tr h="221887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Hostility (z score) 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-0.980 (0.121)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-0.157 (0.551)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1.028 (0.752)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KWT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-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&lt;0.0001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02055789"/>
                  </a:ext>
                </a:extLst>
              </a:tr>
              <a:tr h="221887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Excitement (z score)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-1.039 (0.284)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0.034 (0.573)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0.889 (0.859)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KWT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-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&lt;0.0001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31244032"/>
                  </a:ext>
                </a:extLst>
              </a:tr>
              <a:tr h="221887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Mannerism (z score)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-1.941 (0.00)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-0.232 (1.038)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1.957 (1.643)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KWT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-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&lt;0.0001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95471847"/>
                  </a:ext>
                </a:extLst>
              </a:tr>
              <a:tr h="221887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PMR (z score) 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-1.069 (0.086)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-0.119 (0.503)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1.069 (0.668)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KWT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-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&lt;0.0001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613976"/>
                  </a:ext>
                </a:extLst>
              </a:tr>
              <a:tr h="221887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FTD (z score) 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-1.024 (0.235)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-0.119 (0.503)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1.080 (0.682)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KWT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-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&lt;0.0001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83611043"/>
                  </a:ext>
                </a:extLst>
              </a:tr>
              <a:tr h="221887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Total BPRS 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4.50 (2.79)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30.47 (10.27)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65.36 (17.26)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KWT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-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&lt;0.0001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96139676"/>
                  </a:ext>
                </a:extLst>
              </a:tr>
              <a:tr h="221887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Total HAM-D 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3.78 (2.47)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22.53 (7.60)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35.82 (8.05)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KWT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-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&lt;0.0001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9766388"/>
                  </a:ext>
                </a:extLst>
              </a:tr>
              <a:tr h="221887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Total HAM-A  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6.05 (3.18)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23.33 (6.84)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32.98 (5.83)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KWT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-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&lt;0.0001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0236051"/>
                  </a:ext>
                </a:extLst>
              </a:tr>
              <a:tr h="221887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Total PANSS 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37.68 (6.79)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81.89 (18.94)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130.64 (25.91)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KWT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-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&lt;0.0001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1893989"/>
                  </a:ext>
                </a:extLst>
              </a:tr>
              <a:tr h="221887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Total SANS 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8.28 (3.95)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50.87 (12.95)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83.05 (24.28)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KWT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-</a:t>
                      </a:r>
                      <a:endParaRPr lang="zh-CN" sz="9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900" kern="100" dirty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&lt;0.0001</a:t>
                      </a:r>
                      <a:endParaRPr lang="zh-CN" sz="900" kern="100" dirty="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57427" marR="57427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9571933"/>
                  </a:ext>
                </a:extLst>
              </a:tr>
            </a:tbl>
          </a:graphicData>
        </a:graphic>
      </p:graphicFrame>
      <p:sp>
        <p:nvSpPr>
          <p:cNvPr id="7" name="Rectangle 2">
            <a:extLst>
              <a:ext uri="{FF2B5EF4-FFF2-40B4-BE49-F238E27FC236}">
                <a16:creationId xmlns:a16="http://schemas.microsoft.com/office/drawing/2014/main" id="{8DF0B5BB-8480-886B-92F0-939CE12B0E1A}"/>
              </a:ext>
            </a:extLst>
          </p:cNvPr>
          <p:cNvSpPr>
            <a:spLocks noChangeArrowheads="1"/>
          </p:cNvSpPr>
          <p:nvPr/>
        </p:nvSpPr>
        <p:spPr bwMode="auto">
          <a:xfrm>
            <a:off x="1703727" y="1008879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3470714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2B54CDB0-F87A-D589-0903-8343BD98AC7B}"/>
              </a:ext>
            </a:extLst>
          </p:cNvPr>
          <p:cNvSpPr txBox="1"/>
          <p:nvPr/>
        </p:nvSpPr>
        <p:spPr>
          <a:xfrm>
            <a:off x="142907" y="585565"/>
            <a:ext cx="11352321" cy="31329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altLang="zh-CN" sz="14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Cordia New" panose="020B0304020202020204" pitchFamily="34" charset="-34"/>
              </a:rPr>
              <a:t>ESF, Table 2</a:t>
            </a:r>
            <a:r>
              <a:rPr lang="en-GB" altLang="zh-CN" sz="14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Cordia New" panose="020B0304020202020204" pitchFamily="34" charset="-34"/>
              </a:rPr>
              <a:t>.  Neuropsychological test scores in </a:t>
            </a:r>
            <a:r>
              <a:rPr lang="en-US" altLang="zh-CN" sz="14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Cordia New" panose="020B0304020202020204" pitchFamily="34" charset="-34"/>
              </a:rPr>
              <a:t>simple (SNP) and major neurocognitive psychosis (MNP) and healthy controls (HC).</a:t>
            </a:r>
            <a:endParaRPr lang="zh-CN" altLang="zh-CN" sz="1400" kern="100" dirty="0">
              <a:effectLst/>
              <a:latin typeface="Aptos" panose="020B0004020202020204" pitchFamily="34" charset="0"/>
              <a:ea typeface="等线" panose="02010600030101010101" pitchFamily="2" charset="-122"/>
              <a:cs typeface="Cordia New" panose="020B0304020202020204" pitchFamily="34" charset="-34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A563DDC0-DB07-C14B-11E1-16A690383214}"/>
              </a:ext>
            </a:extLst>
          </p:cNvPr>
          <p:cNvSpPr txBox="1"/>
          <p:nvPr/>
        </p:nvSpPr>
        <p:spPr>
          <a:xfrm>
            <a:off x="731519" y="4194471"/>
            <a:ext cx="8560525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altLang="zh-CN" sz="1100" kern="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All results of univariate GLM analysis; shown are estimated marginal means (SE) after controlling for covariates:  sex, age, and education</a:t>
            </a:r>
            <a:r>
              <a:rPr lang="th-TH" altLang="zh-CN" sz="1100" kern="0" dirty="0">
                <a:effectLst/>
                <a:ea typeface="等线" panose="02010600030101010101" pitchFamily="2" charset="-122"/>
                <a:cs typeface="Times New Roman" panose="02020603050405020304" pitchFamily="18" charset="0"/>
              </a:rPr>
              <a:t>.</a:t>
            </a:r>
            <a:endParaRPr lang="zh-CN" altLang="en-US" sz="1100" dirty="0"/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3D89D2F4-D0AA-ED07-F647-C37983C7BE12}"/>
              </a:ext>
            </a:extLst>
          </p:cNvPr>
          <p:cNvSpPr txBox="1"/>
          <p:nvPr/>
        </p:nvSpPr>
        <p:spPr>
          <a:xfrm>
            <a:off x="731519" y="4409121"/>
            <a:ext cx="8621487" cy="57887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ts val="2000"/>
              </a:lnSpc>
              <a:spcAft>
                <a:spcPts val="800"/>
              </a:spcAft>
            </a:pPr>
            <a:r>
              <a:rPr lang="en-US" altLang="zh-CN" sz="1100" kern="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Cordia New" panose="020B0304020202020204" pitchFamily="34" charset="-34"/>
              </a:rPr>
              <a:t>Post-hoc comparisons among group means show that all cognitive test scores are significantly different among the three study groups and decrease from healthy controls to SNP to MNP.</a:t>
            </a:r>
            <a:endParaRPr lang="zh-CN" altLang="zh-CN" sz="1100" kern="100" dirty="0">
              <a:effectLst/>
              <a:latin typeface="Aptos" panose="020B0004020202020204" pitchFamily="34" charset="0"/>
              <a:ea typeface="等线" panose="02010600030101010101" pitchFamily="2" charset="-122"/>
              <a:cs typeface="Cordia New" panose="020B0304020202020204" pitchFamily="34" charset="-34"/>
            </a:endParaRPr>
          </a:p>
        </p:txBody>
      </p:sp>
      <p:graphicFrame>
        <p:nvGraphicFramePr>
          <p:cNvPr id="14" name="表格 13">
            <a:extLst>
              <a:ext uri="{FF2B5EF4-FFF2-40B4-BE49-F238E27FC236}">
                <a16:creationId xmlns:a16="http://schemas.microsoft.com/office/drawing/2014/main" id="{53ADCD3E-BAF8-42CD-7B9D-0F51C78FA43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88095970"/>
              </p:ext>
            </p:extLst>
          </p:nvPr>
        </p:nvGraphicFramePr>
        <p:xfrm>
          <a:off x="731519" y="1274127"/>
          <a:ext cx="8275277" cy="2894120"/>
        </p:xfrm>
        <a:graphic>
          <a:graphicData uri="http://schemas.openxmlformats.org/drawingml/2006/table">
            <a:tbl>
              <a:tblPr firstRow="1" firstCol="1" bandRow="1"/>
              <a:tblGrid>
                <a:gridCol w="2237713">
                  <a:extLst>
                    <a:ext uri="{9D8B030D-6E8A-4147-A177-3AD203B41FA5}">
                      <a16:colId xmlns:a16="http://schemas.microsoft.com/office/drawing/2014/main" val="1504991982"/>
                    </a:ext>
                  </a:extLst>
                </a:gridCol>
                <a:gridCol w="1655605">
                  <a:extLst>
                    <a:ext uri="{9D8B030D-6E8A-4147-A177-3AD203B41FA5}">
                      <a16:colId xmlns:a16="http://schemas.microsoft.com/office/drawing/2014/main" val="1560982792"/>
                    </a:ext>
                  </a:extLst>
                </a:gridCol>
                <a:gridCol w="1753883">
                  <a:extLst>
                    <a:ext uri="{9D8B030D-6E8A-4147-A177-3AD203B41FA5}">
                      <a16:colId xmlns:a16="http://schemas.microsoft.com/office/drawing/2014/main" val="579726184"/>
                    </a:ext>
                  </a:extLst>
                </a:gridCol>
                <a:gridCol w="1556640">
                  <a:extLst>
                    <a:ext uri="{9D8B030D-6E8A-4147-A177-3AD203B41FA5}">
                      <a16:colId xmlns:a16="http://schemas.microsoft.com/office/drawing/2014/main" val="785145846"/>
                    </a:ext>
                  </a:extLst>
                </a:gridCol>
                <a:gridCol w="1071436">
                  <a:extLst>
                    <a:ext uri="{9D8B030D-6E8A-4147-A177-3AD203B41FA5}">
                      <a16:colId xmlns:a16="http://schemas.microsoft.com/office/drawing/2014/main" val="1641585157"/>
                    </a:ext>
                  </a:extLst>
                </a:gridCol>
              </a:tblGrid>
              <a:tr h="361765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200" b="1" kern="100">
                          <a:solidFill>
                            <a:srgbClr val="000000"/>
                          </a:solidFill>
                          <a:effectLst/>
                          <a:highlight>
                            <a:srgbClr val="E8E8E8"/>
                          </a:highlight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Variables</a:t>
                      </a:r>
                      <a:endParaRPr lang="zh-CN" sz="1100" kern="100">
                        <a:effectLst/>
                        <a:highlight>
                          <a:srgbClr val="E8E8E8"/>
                        </a:highlight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8E8E8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200" b="1" kern="100">
                          <a:solidFill>
                            <a:srgbClr val="000000"/>
                          </a:solidFill>
                          <a:effectLst/>
                          <a:highlight>
                            <a:srgbClr val="E8E8E8"/>
                          </a:highlight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HC</a:t>
                      </a:r>
                      <a:endParaRPr lang="zh-CN" sz="1100" kern="100">
                        <a:effectLst/>
                        <a:highlight>
                          <a:srgbClr val="E8E8E8"/>
                        </a:highlight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8E8E8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200" b="1" kern="100">
                          <a:solidFill>
                            <a:srgbClr val="000000"/>
                          </a:solidFill>
                          <a:effectLst/>
                          <a:highlight>
                            <a:srgbClr val="E8E8E8"/>
                          </a:highlight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SNP</a:t>
                      </a:r>
                      <a:endParaRPr lang="zh-CN" sz="1100" kern="100">
                        <a:effectLst/>
                        <a:highlight>
                          <a:srgbClr val="E8E8E8"/>
                        </a:highlight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8E8E8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200" b="1" kern="100">
                          <a:solidFill>
                            <a:srgbClr val="000000"/>
                          </a:solidFill>
                          <a:effectLst/>
                          <a:highlight>
                            <a:srgbClr val="E8E8E8"/>
                          </a:highlight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MNP</a:t>
                      </a:r>
                      <a:endParaRPr lang="zh-CN" sz="1100" kern="100">
                        <a:effectLst/>
                        <a:highlight>
                          <a:srgbClr val="E8E8E8"/>
                        </a:highlight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8E8E8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200" b="1" kern="100">
                          <a:solidFill>
                            <a:srgbClr val="000000"/>
                          </a:solidFill>
                          <a:effectLst/>
                          <a:highlight>
                            <a:srgbClr val="E8E8E8"/>
                          </a:highlight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p</a:t>
                      </a:r>
                      <a:endParaRPr lang="zh-CN" sz="1100" kern="100">
                        <a:effectLst/>
                        <a:highlight>
                          <a:srgbClr val="E8E8E8"/>
                        </a:highlight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8E8E8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03620604"/>
                  </a:ext>
                </a:extLst>
              </a:tr>
              <a:tr h="361765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200" kern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List learning</a:t>
                      </a:r>
                      <a:endParaRPr lang="zh-CN" sz="11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2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51.33 (1.32)</a:t>
                      </a:r>
                      <a:endParaRPr lang="zh-CN" sz="11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2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22.25 (1.21)</a:t>
                      </a:r>
                      <a:endParaRPr lang="zh-CN" sz="11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2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17.22 (1.22)</a:t>
                      </a:r>
                      <a:endParaRPr lang="zh-CN" sz="11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2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&lt;0.001</a:t>
                      </a:r>
                      <a:endParaRPr lang="zh-CN" sz="11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72760740"/>
                  </a:ext>
                </a:extLst>
              </a:tr>
              <a:tr h="361765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200" kern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Digit sequencing</a:t>
                      </a:r>
                      <a:endParaRPr lang="zh-CN" sz="11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2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26.80 (0.92)</a:t>
                      </a:r>
                      <a:endParaRPr lang="zh-CN" sz="11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2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11.46 (0.84)</a:t>
                      </a:r>
                      <a:endParaRPr lang="zh-CN" sz="11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2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7.41 </a:t>
                      </a: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(</a:t>
                      </a:r>
                      <a:r>
                        <a:rPr lang="bg-BG" sz="12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0</a:t>
                      </a:r>
                      <a:r>
                        <a:rPr lang="en-GB" sz="12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.85)</a:t>
                      </a:r>
                      <a:endParaRPr lang="zh-CN" sz="11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2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&lt;0.001</a:t>
                      </a:r>
                      <a:endParaRPr lang="zh-CN" sz="11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29752084"/>
                  </a:ext>
                </a:extLst>
              </a:tr>
              <a:tr h="361765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200" kern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Token motor task</a:t>
                      </a:r>
                      <a:endParaRPr lang="zh-CN" sz="11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2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95.98 (2.60)</a:t>
                      </a:r>
                      <a:endParaRPr lang="zh-CN" sz="11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2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54.94 (2.39)</a:t>
                      </a:r>
                      <a:endParaRPr lang="zh-CN" sz="11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2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28.760 (2.407)</a:t>
                      </a:r>
                      <a:endParaRPr lang="zh-CN" sz="11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2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&lt;0.001</a:t>
                      </a:r>
                      <a:endParaRPr lang="zh-CN" sz="11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36295963"/>
                  </a:ext>
                </a:extLst>
              </a:tr>
              <a:tr h="361765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200" kern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Category Instances</a:t>
                      </a:r>
                      <a:endParaRPr lang="zh-CN" sz="11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2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16.70 (0.45)</a:t>
                      </a:r>
                      <a:endParaRPr lang="zh-CN" sz="11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2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7.307 (0.41)</a:t>
                      </a:r>
                      <a:endParaRPr lang="zh-CN" sz="11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2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6.093 (0.413)</a:t>
                      </a:r>
                      <a:endParaRPr lang="zh-CN" sz="11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2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&lt;0.001</a:t>
                      </a:r>
                      <a:endParaRPr lang="zh-CN" sz="11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47099209"/>
                  </a:ext>
                </a:extLst>
              </a:tr>
              <a:tr h="361765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200" kern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Symbol coding</a:t>
                      </a:r>
                      <a:endParaRPr lang="zh-CN" sz="11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2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48.41 (1.59)</a:t>
                      </a:r>
                      <a:endParaRPr lang="zh-CN" sz="11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2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14.99 (1.46)</a:t>
                      </a:r>
                      <a:endParaRPr lang="zh-CN" sz="11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2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6.09 (0.41)</a:t>
                      </a:r>
                      <a:endParaRPr lang="zh-CN" sz="11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2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&lt;0.001</a:t>
                      </a:r>
                      <a:endParaRPr lang="zh-CN" sz="11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33916878"/>
                  </a:ext>
                </a:extLst>
              </a:tr>
              <a:tr h="361765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200" kern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Tower of London</a:t>
                      </a:r>
                      <a:endParaRPr lang="zh-CN" sz="11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2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18.44 (0.44)</a:t>
                      </a:r>
                      <a:endParaRPr lang="zh-CN" sz="11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2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7.70 (0.40)</a:t>
                      </a:r>
                      <a:endParaRPr lang="zh-CN" sz="11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2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3.98 (0.40)</a:t>
                      </a:r>
                      <a:endParaRPr lang="zh-CN" sz="11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2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&lt;0.001</a:t>
                      </a:r>
                      <a:endParaRPr lang="zh-CN" sz="11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68538347"/>
                  </a:ext>
                </a:extLst>
              </a:tr>
              <a:tr h="361765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200" kern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Total BACs score</a:t>
                      </a:r>
                      <a:endParaRPr lang="zh-CN" sz="11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2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266.55 (4.33)</a:t>
                      </a:r>
                      <a:endParaRPr lang="zh-CN" sz="11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2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123.58 (3.98)</a:t>
                      </a:r>
                      <a:endParaRPr lang="zh-CN" sz="11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2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71.52 (4.01)</a:t>
                      </a:r>
                      <a:endParaRPr lang="zh-CN" sz="11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200" kern="100" dirty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&lt;0.001</a:t>
                      </a:r>
                      <a:endParaRPr lang="zh-CN" sz="1100" kern="100" dirty="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551794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5701467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>
            <a:extLst>
              <a:ext uri="{FF2B5EF4-FFF2-40B4-BE49-F238E27FC236}">
                <a16:creationId xmlns:a16="http://schemas.microsoft.com/office/drawing/2014/main" id="{70D1347A-AA3E-FB3D-454D-BEAA16104F5A}"/>
              </a:ext>
            </a:extLst>
          </p:cNvPr>
          <p:cNvSpPr txBox="1"/>
          <p:nvPr/>
        </p:nvSpPr>
        <p:spPr>
          <a:xfrm>
            <a:off x="165969" y="510591"/>
            <a:ext cx="11652069" cy="31329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altLang="zh-CN" sz="14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Cordia New" panose="020B0304020202020204" pitchFamily="34" charset="-34"/>
              </a:rPr>
              <a:t>ESF, Table 3</a:t>
            </a:r>
            <a:r>
              <a:rPr lang="en-GB" altLang="zh-CN" sz="14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Cordia New" panose="020B0304020202020204" pitchFamily="34" charset="-34"/>
              </a:rPr>
              <a:t>. Measurements of biomarkers in </a:t>
            </a:r>
            <a:r>
              <a:rPr lang="en-US" altLang="zh-CN" sz="14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Cordia New" panose="020B0304020202020204" pitchFamily="34" charset="-34"/>
              </a:rPr>
              <a:t>simple (SNP) and major neurocognitive psychosis (MNP) and healthy controls (HC).</a:t>
            </a:r>
            <a:endParaRPr lang="zh-CN" altLang="zh-CN" sz="1400" kern="100" dirty="0">
              <a:effectLst/>
              <a:latin typeface="Aptos" panose="020B0004020202020204" pitchFamily="34" charset="0"/>
              <a:ea typeface="等线" panose="02010600030101010101" pitchFamily="2" charset="-122"/>
              <a:cs typeface="Cordia New" panose="020B0304020202020204" pitchFamily="34" charset="-34"/>
            </a:endParaRPr>
          </a:p>
        </p:txBody>
      </p:sp>
      <p:graphicFrame>
        <p:nvGraphicFramePr>
          <p:cNvPr id="5" name="表格 4">
            <a:extLst>
              <a:ext uri="{FF2B5EF4-FFF2-40B4-BE49-F238E27FC236}">
                <a16:creationId xmlns:a16="http://schemas.microsoft.com/office/drawing/2014/main" id="{6661B6C6-BA61-4C75-4CA5-95FBC9B747E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88899047"/>
              </p:ext>
            </p:extLst>
          </p:nvPr>
        </p:nvGraphicFramePr>
        <p:xfrm>
          <a:off x="1078331" y="1408258"/>
          <a:ext cx="8272145" cy="2747118"/>
        </p:xfrm>
        <a:graphic>
          <a:graphicData uri="http://schemas.openxmlformats.org/drawingml/2006/table">
            <a:tbl>
              <a:tblPr firstRow="1" firstCol="1" bandRow="1"/>
              <a:tblGrid>
                <a:gridCol w="2607310">
                  <a:extLst>
                    <a:ext uri="{9D8B030D-6E8A-4147-A177-3AD203B41FA5}">
                      <a16:colId xmlns:a16="http://schemas.microsoft.com/office/drawing/2014/main" val="2870758293"/>
                    </a:ext>
                  </a:extLst>
                </a:gridCol>
                <a:gridCol w="1438275">
                  <a:extLst>
                    <a:ext uri="{9D8B030D-6E8A-4147-A177-3AD203B41FA5}">
                      <a16:colId xmlns:a16="http://schemas.microsoft.com/office/drawing/2014/main" val="4099346552"/>
                    </a:ext>
                  </a:extLst>
                </a:gridCol>
                <a:gridCol w="1530350">
                  <a:extLst>
                    <a:ext uri="{9D8B030D-6E8A-4147-A177-3AD203B41FA5}">
                      <a16:colId xmlns:a16="http://schemas.microsoft.com/office/drawing/2014/main" val="1216593749"/>
                    </a:ext>
                  </a:extLst>
                </a:gridCol>
                <a:gridCol w="1619885">
                  <a:extLst>
                    <a:ext uri="{9D8B030D-6E8A-4147-A177-3AD203B41FA5}">
                      <a16:colId xmlns:a16="http://schemas.microsoft.com/office/drawing/2014/main" val="3853717288"/>
                    </a:ext>
                  </a:extLst>
                </a:gridCol>
                <a:gridCol w="1076325">
                  <a:extLst>
                    <a:ext uri="{9D8B030D-6E8A-4147-A177-3AD203B41FA5}">
                      <a16:colId xmlns:a16="http://schemas.microsoft.com/office/drawing/2014/main" val="3114947180"/>
                    </a:ext>
                  </a:extLst>
                </a:gridCol>
              </a:tblGrid>
              <a:tr h="282678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200" b="1" kern="100" dirty="0">
                          <a:solidFill>
                            <a:srgbClr val="000000"/>
                          </a:solidFill>
                          <a:effectLst/>
                          <a:highlight>
                            <a:srgbClr val="D1D1D1"/>
                          </a:highlight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Variables</a:t>
                      </a:r>
                      <a:endParaRPr lang="zh-CN" sz="1100" kern="100" dirty="0">
                        <a:effectLst/>
                        <a:highlight>
                          <a:srgbClr val="D1D1D1"/>
                        </a:highlight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1D1D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200" b="1" kern="100">
                          <a:solidFill>
                            <a:srgbClr val="000000"/>
                          </a:solidFill>
                          <a:effectLst/>
                          <a:highlight>
                            <a:srgbClr val="D1D1D1"/>
                          </a:highlight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HC a</a:t>
                      </a:r>
                      <a:endParaRPr lang="zh-CN" sz="1100" kern="100">
                        <a:effectLst/>
                        <a:highlight>
                          <a:srgbClr val="D1D1D1"/>
                        </a:highlight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1D1D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200" b="1" kern="100" dirty="0">
                          <a:solidFill>
                            <a:srgbClr val="000000"/>
                          </a:solidFill>
                          <a:effectLst/>
                          <a:highlight>
                            <a:srgbClr val="D1D1D1"/>
                          </a:highlight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SNP b</a:t>
                      </a:r>
                      <a:endParaRPr lang="zh-CN" sz="1100" kern="100" dirty="0">
                        <a:effectLst/>
                        <a:highlight>
                          <a:srgbClr val="D1D1D1"/>
                        </a:highlight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1D1D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200" b="1" kern="100">
                          <a:solidFill>
                            <a:srgbClr val="000000"/>
                          </a:solidFill>
                          <a:effectLst/>
                          <a:highlight>
                            <a:srgbClr val="D1D1D1"/>
                          </a:highlight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MNP c</a:t>
                      </a:r>
                      <a:endParaRPr lang="zh-CN" sz="1100" kern="100">
                        <a:effectLst/>
                        <a:highlight>
                          <a:srgbClr val="D1D1D1"/>
                        </a:highlight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1D1D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200" b="1" kern="100" dirty="0">
                          <a:solidFill>
                            <a:srgbClr val="000000"/>
                          </a:solidFill>
                          <a:effectLst/>
                          <a:highlight>
                            <a:srgbClr val="D1D1D1"/>
                          </a:highlight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p</a:t>
                      </a:r>
                      <a:endParaRPr lang="zh-CN" sz="1100" kern="100" dirty="0">
                        <a:effectLst/>
                        <a:highlight>
                          <a:srgbClr val="D1D1D1"/>
                        </a:highlight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1D1D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7507569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200" kern="0" dirty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IL-1β (</a:t>
                      </a:r>
                      <a:r>
                        <a:rPr lang="en-US" sz="1200" kern="0" dirty="0" err="1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pg</a:t>
                      </a:r>
                      <a:r>
                        <a:rPr lang="en-US" sz="1200" kern="0" dirty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/mL)</a:t>
                      </a:r>
                      <a:endParaRPr lang="zh-CN" sz="1100" kern="100" dirty="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200" kern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2</a:t>
                      </a:r>
                      <a:r>
                        <a:rPr lang="th-TH" sz="1200" kern="0">
                          <a:effectLst/>
                          <a:latin typeface="Aptos" panose="020B00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.</a:t>
                      </a:r>
                      <a:r>
                        <a:rPr lang="en-US" sz="1200" kern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44 (</a:t>
                      </a:r>
                      <a:r>
                        <a:rPr lang="bg-BG" sz="1200" kern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0</a:t>
                      </a:r>
                      <a:r>
                        <a:rPr lang="th-TH" sz="1200" kern="0">
                          <a:effectLst/>
                          <a:latin typeface="Aptos" panose="020B00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.</a:t>
                      </a:r>
                      <a:r>
                        <a:rPr lang="en-US" sz="1200" kern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14) </a:t>
                      </a:r>
                      <a:r>
                        <a:rPr lang="en-US" sz="1200" kern="0" baseline="300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b,c</a:t>
                      </a:r>
                      <a:endParaRPr lang="zh-CN" sz="11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2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3.45 (0.14) </a:t>
                      </a:r>
                      <a:r>
                        <a:rPr lang="en-GB" sz="1200" kern="100" baseline="300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a</a:t>
                      </a:r>
                      <a:endParaRPr lang="zh-CN" sz="11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2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3.82 (0.14) </a:t>
                      </a:r>
                      <a:r>
                        <a:rPr lang="en-GB" sz="1200" kern="100" baseline="300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a</a:t>
                      </a:r>
                      <a:endParaRPr lang="zh-CN" sz="11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200" kern="100" dirty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&lt;0.001</a:t>
                      </a:r>
                      <a:endParaRPr lang="zh-CN" sz="1100" kern="100" dirty="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8364684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200" kern="0" dirty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IL</a:t>
                      </a:r>
                      <a:r>
                        <a:rPr lang="th-TH" sz="1200" kern="0" dirty="0">
                          <a:effectLst/>
                          <a:latin typeface="Aptos" panose="020B00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-</a:t>
                      </a:r>
                      <a:r>
                        <a:rPr lang="en-US" sz="1200" kern="0" dirty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6 (</a:t>
                      </a:r>
                      <a:r>
                        <a:rPr lang="en-US" sz="1200" kern="0" dirty="0" err="1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pg</a:t>
                      </a:r>
                      <a:r>
                        <a:rPr lang="th-TH" sz="1200" kern="0" dirty="0">
                          <a:effectLst/>
                          <a:latin typeface="Aptos" panose="020B00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/</a:t>
                      </a:r>
                      <a:r>
                        <a:rPr lang="en-US" sz="1200" kern="0" dirty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ml)</a:t>
                      </a:r>
                      <a:endParaRPr lang="zh-CN" sz="1100" kern="100" dirty="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2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5.66 (0.53) </a:t>
                      </a:r>
                      <a:r>
                        <a:rPr lang="en-GB" sz="1200" kern="100" baseline="300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c</a:t>
                      </a:r>
                      <a:endParaRPr lang="zh-CN" sz="11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2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5.83 (0.50) </a:t>
                      </a:r>
                      <a:r>
                        <a:rPr lang="en-GB" sz="1200" kern="100" baseline="300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c</a:t>
                      </a:r>
                      <a:endParaRPr lang="zh-CN" sz="11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2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8.55 (0.50) </a:t>
                      </a:r>
                      <a:r>
                        <a:rPr lang="en-GB" sz="1200" kern="100" baseline="300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a,b</a:t>
                      </a:r>
                      <a:endParaRPr lang="zh-CN" sz="11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2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&lt;0.001</a:t>
                      </a:r>
                      <a:endParaRPr lang="zh-CN" sz="11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8040874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200" kern="0" dirty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TNF-α (</a:t>
                      </a:r>
                      <a:r>
                        <a:rPr lang="en-US" sz="1200" kern="0" dirty="0" err="1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pg</a:t>
                      </a:r>
                      <a:r>
                        <a:rPr lang="th-TH" sz="1200" kern="0" dirty="0">
                          <a:effectLst/>
                          <a:latin typeface="Aptos" panose="020B00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/</a:t>
                      </a:r>
                      <a:r>
                        <a:rPr lang="en-US" sz="1200" kern="0" dirty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ml)</a:t>
                      </a:r>
                      <a:endParaRPr lang="zh-CN" sz="1100" kern="100" dirty="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2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19.39 (1.96) </a:t>
                      </a:r>
                      <a:r>
                        <a:rPr lang="en-GB" sz="1200" kern="100" baseline="300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b,c</a:t>
                      </a:r>
                      <a:endParaRPr lang="zh-CN" sz="11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2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41.94 (1.86)</a:t>
                      </a:r>
                      <a:r>
                        <a:rPr lang="en-GB" sz="1200" kern="100" baseline="300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 a</a:t>
                      </a:r>
                      <a:endParaRPr lang="zh-CN" sz="11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2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47.16 (1.87) </a:t>
                      </a:r>
                      <a:r>
                        <a:rPr lang="en-GB" sz="1200" kern="100" baseline="300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a</a:t>
                      </a:r>
                      <a:endParaRPr lang="zh-CN" sz="11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2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&lt;0.001</a:t>
                      </a:r>
                      <a:endParaRPr lang="zh-CN" sz="11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3502048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200" kern="0" dirty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IL</a:t>
                      </a:r>
                      <a:r>
                        <a:rPr lang="th-TH" sz="1200" kern="0" dirty="0">
                          <a:effectLst/>
                          <a:latin typeface="Aptos" panose="020B00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-</a:t>
                      </a:r>
                      <a:r>
                        <a:rPr lang="en-US" sz="1200" kern="0" dirty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17 (</a:t>
                      </a:r>
                      <a:r>
                        <a:rPr lang="en-US" sz="1200" kern="0" dirty="0" err="1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pg</a:t>
                      </a:r>
                      <a:r>
                        <a:rPr lang="th-TH" sz="1200" kern="0" dirty="0">
                          <a:effectLst/>
                          <a:latin typeface="Aptos" panose="020B00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/</a:t>
                      </a:r>
                      <a:r>
                        <a:rPr lang="en-US" sz="1200" kern="0" dirty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ml)</a:t>
                      </a:r>
                      <a:endParaRPr lang="zh-CN" sz="1100" kern="100" dirty="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200" kern="100" dirty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16.68 (1.54) </a:t>
                      </a:r>
                      <a:r>
                        <a:rPr lang="en-GB" sz="1200" kern="100" baseline="30000" dirty="0" err="1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b,c</a:t>
                      </a:r>
                      <a:endParaRPr lang="zh-CN" sz="1100" kern="100" dirty="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2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41.17 (1.45) </a:t>
                      </a:r>
                      <a:r>
                        <a:rPr lang="en-GB" sz="1200" kern="100" baseline="300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a,c</a:t>
                      </a:r>
                      <a:endParaRPr lang="zh-CN" sz="11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2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48.22 (1.46) </a:t>
                      </a:r>
                      <a:r>
                        <a:rPr lang="en-GB" sz="1200" kern="100" baseline="300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a,b</a:t>
                      </a:r>
                      <a:endParaRPr lang="zh-CN" sz="11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2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&lt;0.001</a:t>
                      </a:r>
                      <a:endParaRPr lang="zh-CN" sz="11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0744023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200" kern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IL</a:t>
                      </a:r>
                      <a:r>
                        <a:rPr lang="th-TH" sz="1200" kern="0">
                          <a:effectLst/>
                          <a:latin typeface="Aptos" panose="020B00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-</a:t>
                      </a:r>
                      <a:r>
                        <a:rPr lang="en-US" sz="1200" kern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21 (pg</a:t>
                      </a:r>
                      <a:r>
                        <a:rPr lang="th-TH" sz="1200" kern="0">
                          <a:effectLst/>
                          <a:latin typeface="Aptos" panose="020B00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/</a:t>
                      </a:r>
                      <a:r>
                        <a:rPr lang="en-US" sz="1200" kern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ml)</a:t>
                      </a:r>
                      <a:endParaRPr lang="zh-CN" sz="11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200" kern="100" dirty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155.75 (14.63) </a:t>
                      </a:r>
                      <a:r>
                        <a:rPr lang="en-GB" sz="1200" kern="100" baseline="30000" dirty="0" err="1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b,c</a:t>
                      </a:r>
                      <a:endParaRPr lang="zh-CN" sz="1100" kern="100" dirty="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2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237.30 (13.76) </a:t>
                      </a:r>
                      <a:r>
                        <a:rPr lang="en-GB" sz="1200" kern="100" baseline="300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a</a:t>
                      </a:r>
                      <a:endParaRPr lang="zh-CN" sz="11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2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271.234 (13.839) </a:t>
                      </a:r>
                      <a:r>
                        <a:rPr lang="en-GB" sz="1200" kern="100" baseline="300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a</a:t>
                      </a:r>
                      <a:endParaRPr lang="zh-CN" sz="11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2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&lt;0.001</a:t>
                      </a:r>
                      <a:endParaRPr lang="zh-CN" sz="11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5349205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200" kern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IL</a:t>
                      </a:r>
                      <a:r>
                        <a:rPr lang="th-TH" sz="1200" kern="0">
                          <a:effectLst/>
                          <a:latin typeface="Aptos" panose="020B00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-</a:t>
                      </a:r>
                      <a:r>
                        <a:rPr lang="en-US" sz="1200" kern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22 ( pg</a:t>
                      </a:r>
                      <a:r>
                        <a:rPr lang="th-TH" sz="1200" kern="0">
                          <a:effectLst/>
                          <a:latin typeface="Aptos" panose="020B00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/</a:t>
                      </a:r>
                      <a:r>
                        <a:rPr lang="en-US" sz="1200" kern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ml)</a:t>
                      </a:r>
                      <a:endParaRPr lang="zh-CN" sz="11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200" kern="100" dirty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17.83 (1.11) </a:t>
                      </a:r>
                      <a:r>
                        <a:rPr lang="en-GB" sz="1200" kern="100" baseline="30000" dirty="0" err="1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b,c</a:t>
                      </a:r>
                      <a:endParaRPr lang="zh-CN" sz="1100" kern="100" dirty="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2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27.96 (1.05)</a:t>
                      </a:r>
                      <a:r>
                        <a:rPr lang="en-GB" sz="1200" kern="100" baseline="300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 a</a:t>
                      </a:r>
                      <a:endParaRPr lang="zh-CN" sz="11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2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28.42 (1.05) </a:t>
                      </a:r>
                      <a:r>
                        <a:rPr lang="en-GB" sz="1200" kern="100" baseline="300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a</a:t>
                      </a:r>
                      <a:endParaRPr lang="zh-CN" sz="11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2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&lt;0.001</a:t>
                      </a:r>
                      <a:endParaRPr lang="zh-CN" sz="11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0341287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200" kern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IL</a:t>
                      </a:r>
                      <a:r>
                        <a:rPr lang="th-TH" sz="1200" kern="0">
                          <a:effectLst/>
                          <a:latin typeface="Aptos" panose="020B00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-</a:t>
                      </a:r>
                      <a:r>
                        <a:rPr lang="en-US" sz="1200" kern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23 (pg</a:t>
                      </a:r>
                      <a:r>
                        <a:rPr lang="th-TH" sz="1200" kern="0">
                          <a:effectLst/>
                          <a:latin typeface="Aptos" panose="020B00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/</a:t>
                      </a:r>
                      <a:r>
                        <a:rPr lang="en-US" sz="1200" kern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ml)</a:t>
                      </a:r>
                      <a:endParaRPr lang="zh-CN" sz="11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2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13.90 (2.27) </a:t>
                      </a:r>
                      <a:r>
                        <a:rPr lang="en-GB" sz="1200" kern="100" baseline="300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b,c</a:t>
                      </a:r>
                      <a:endParaRPr lang="zh-CN" sz="11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200" kern="100" dirty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20.05 (2.14) </a:t>
                      </a:r>
                      <a:r>
                        <a:rPr lang="en-GB" sz="1200" kern="100" baseline="30000" dirty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c</a:t>
                      </a:r>
                      <a:endParaRPr lang="zh-CN" sz="1100" kern="100" dirty="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2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31.36 (2.15) </a:t>
                      </a:r>
                      <a:r>
                        <a:rPr lang="en-GB" sz="1200" kern="100" baseline="300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a,b</a:t>
                      </a:r>
                      <a:endParaRPr lang="zh-CN" sz="11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2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&lt;0.001</a:t>
                      </a:r>
                      <a:endParaRPr lang="zh-CN" sz="11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1378346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200" kern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Classical M1 macrophage (z scores)</a:t>
                      </a:r>
                      <a:endParaRPr lang="zh-CN" sz="11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2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-2.09 (0.25) </a:t>
                      </a:r>
                      <a:r>
                        <a:rPr lang="en-GB" sz="1200" kern="100" baseline="300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b,c</a:t>
                      </a:r>
                      <a:endParaRPr lang="zh-CN" sz="11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200" kern="100" dirty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0.22 (0.23) </a:t>
                      </a:r>
                      <a:r>
                        <a:rPr lang="en-GB" sz="1200" kern="100" baseline="30000" dirty="0" err="1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a,c</a:t>
                      </a:r>
                      <a:endParaRPr lang="zh-CN" sz="1100" kern="100" dirty="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2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1.63 (0.23) </a:t>
                      </a:r>
                      <a:r>
                        <a:rPr lang="en-GB" sz="1200" kern="100" baseline="300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a,b</a:t>
                      </a:r>
                      <a:endParaRPr lang="zh-CN" sz="11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2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&lt;0.001</a:t>
                      </a:r>
                      <a:endParaRPr lang="zh-CN" sz="11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3940717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200" kern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Th-17 axis (z scores)</a:t>
                      </a:r>
                      <a:endParaRPr lang="zh-CN" sz="11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2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-2.00 (0.24) </a:t>
                      </a:r>
                      <a:r>
                        <a:rPr lang="en-GB" sz="1200" kern="100" baseline="300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b,c</a:t>
                      </a:r>
                      <a:endParaRPr lang="zh-CN" sz="11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2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-0.07 (0.22) </a:t>
                      </a:r>
                      <a:r>
                        <a:rPr lang="en-GB" sz="1200" kern="100" baseline="300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a,c</a:t>
                      </a:r>
                      <a:endParaRPr lang="zh-CN" sz="11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200" kern="100" dirty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1.84 (0.22) </a:t>
                      </a:r>
                      <a:r>
                        <a:rPr lang="en-GB" sz="1200" kern="100" baseline="30000" dirty="0" err="1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a,b</a:t>
                      </a:r>
                      <a:endParaRPr lang="zh-CN" sz="1100" kern="100" dirty="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2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&lt;0.001</a:t>
                      </a:r>
                      <a:endParaRPr lang="zh-CN" sz="11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5352612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200" kern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IRS index (z scores)</a:t>
                      </a:r>
                      <a:endParaRPr lang="zh-CN" sz="11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2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-1.16 (0.09) </a:t>
                      </a:r>
                      <a:r>
                        <a:rPr lang="en-GB" sz="1200" kern="100" baseline="300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b,c</a:t>
                      </a:r>
                      <a:endParaRPr lang="zh-CN" sz="11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2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0.194(0.09) </a:t>
                      </a:r>
                      <a:r>
                        <a:rPr lang="en-GB" sz="1200" kern="100" baseline="300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a,c</a:t>
                      </a:r>
                      <a:endParaRPr lang="zh-CN" sz="1100" kern="10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200" kern="100" dirty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0.841 (0.09) </a:t>
                      </a:r>
                      <a:r>
                        <a:rPr lang="en-GB" sz="1200" kern="100" baseline="30000" dirty="0" err="1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a,b</a:t>
                      </a:r>
                      <a:endParaRPr lang="zh-CN" sz="1100" kern="100" dirty="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200" kern="100" dirty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Cordia New" panose="020B0304020202020204" pitchFamily="34" charset="-34"/>
                        </a:rPr>
                        <a:t>&lt;0.001</a:t>
                      </a:r>
                      <a:endParaRPr lang="zh-CN" sz="1100" kern="100" dirty="0">
                        <a:effectLst/>
                        <a:latin typeface="Aptos" panose="020B0004020202020204" pitchFamily="34" charset="0"/>
                        <a:ea typeface="等线" panose="02010600030101010101" pitchFamily="2" charset="-122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54890294"/>
                  </a:ext>
                </a:extLst>
              </a:tr>
            </a:tbl>
          </a:graphicData>
        </a:graphic>
      </p:graphicFrame>
      <p:sp>
        <p:nvSpPr>
          <p:cNvPr id="7" name="文本框 6">
            <a:extLst>
              <a:ext uri="{FF2B5EF4-FFF2-40B4-BE49-F238E27FC236}">
                <a16:creationId xmlns:a16="http://schemas.microsoft.com/office/drawing/2014/main" id="{C0C3ABE9-7155-A67A-C39F-1B06212A8F60}"/>
              </a:ext>
            </a:extLst>
          </p:cNvPr>
          <p:cNvSpPr txBox="1"/>
          <p:nvPr/>
        </p:nvSpPr>
        <p:spPr>
          <a:xfrm>
            <a:off x="978762" y="4255217"/>
            <a:ext cx="8467079" cy="80534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38100" marR="38100">
              <a:spcAft>
                <a:spcPts val="800"/>
              </a:spcAft>
            </a:pPr>
            <a:r>
              <a:rPr lang="en-GB" altLang="zh-CN" sz="1100" kern="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Cordia New" panose="020B0304020202020204" pitchFamily="34" charset="-34"/>
              </a:rPr>
              <a:t>All results of univariate GLM analysis; shown are estimated marginal means (SE) after controlling for covariates (</a:t>
            </a:r>
            <a:r>
              <a:rPr lang="en-US" altLang="zh-CN" sz="1100" kern="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Cordia New" panose="020B0304020202020204" pitchFamily="34" charset="-34"/>
              </a:rPr>
              <a:t>sex, age and BMI).</a:t>
            </a:r>
            <a:endParaRPr lang="zh-CN" altLang="zh-CN" sz="1100" kern="100" dirty="0">
              <a:effectLst/>
              <a:latin typeface="Aptos" panose="020B0004020202020204" pitchFamily="34" charset="0"/>
              <a:ea typeface="等线" panose="02010600030101010101" pitchFamily="2" charset="-122"/>
              <a:cs typeface="Cordia New" panose="020B0304020202020204" pitchFamily="34" charset="-34"/>
            </a:endParaRPr>
          </a:p>
          <a:p>
            <a:pPr marL="38100" marR="38100">
              <a:spcAft>
                <a:spcPts val="800"/>
              </a:spcAft>
            </a:pPr>
            <a:r>
              <a:rPr lang="en-US" altLang="zh-CN" sz="1100" kern="0" baseline="300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Cordia New" panose="020B0304020202020204" pitchFamily="34" charset="-34"/>
              </a:rPr>
              <a:t>a,b,c</a:t>
            </a:r>
            <a:r>
              <a:rPr lang="en-US" altLang="zh-CN" sz="1100" kern="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Cordia New" panose="020B0304020202020204" pitchFamily="34" charset="-34"/>
              </a:rPr>
              <a:t>: multiple post-hoc comparisons among group means. </a:t>
            </a:r>
            <a:endParaRPr lang="zh-CN" altLang="zh-CN" sz="1100" kern="100" dirty="0">
              <a:effectLst/>
              <a:latin typeface="Aptos" panose="020B0004020202020204" pitchFamily="34" charset="0"/>
              <a:ea typeface="等线" panose="02010600030101010101" pitchFamily="2" charset="-122"/>
              <a:cs typeface="Cordia New" panose="020B0304020202020204" pitchFamily="34" charset="-34"/>
            </a:endParaRPr>
          </a:p>
          <a:p>
            <a:r>
              <a:rPr lang="en-US" altLang="zh-CN" sz="1100" kern="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IL: interleukin, TNF: tumor necrosis factor, Th-: T helper, IRS: immune-inflammatory response system. </a:t>
            </a:r>
            <a:endParaRPr lang="zh-CN" altLang="en-US" sz="1100" dirty="0"/>
          </a:p>
        </p:txBody>
      </p:sp>
    </p:spTree>
    <p:extLst>
      <p:ext uri="{BB962C8B-B14F-4D97-AF65-F5344CB8AC3E}">
        <p14:creationId xmlns:p14="http://schemas.microsoft.com/office/powerpoint/2010/main" val="100061908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B782FB7A-5C6A-1213-165F-5DA699BC26D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99314"/>
            <a:ext cx="12192000" cy="645937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6580132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E06564B0-B664-D73D-95E8-5ABD134B0E31}"/>
              </a:ext>
            </a:extLst>
          </p:cNvPr>
          <p:cNvSpPr txBox="1"/>
          <p:nvPr/>
        </p:nvSpPr>
        <p:spPr>
          <a:xfrm>
            <a:off x="1876926" y="1763031"/>
            <a:ext cx="8993606" cy="56194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</a:pPr>
            <a:r>
              <a:rPr lang="en-US" sz="1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SF, Figure 1</a:t>
            </a:r>
            <a:r>
              <a:rPr lang="en-US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Results of linear discriminant analysis.</a:t>
            </a:r>
          </a:p>
        </p:txBody>
      </p:sp>
    </p:spTree>
    <p:extLst>
      <p:ext uri="{BB962C8B-B14F-4D97-AF65-F5344CB8AC3E}">
        <p14:creationId xmlns:p14="http://schemas.microsoft.com/office/powerpoint/2010/main" val="330545660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06D6B3D6-E933-84E4-C4B6-456C4385D03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14337" y="433387"/>
            <a:ext cx="11363325" cy="59912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4054557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1168B389-1F37-85B8-9EA6-6F970A5FFB98}"/>
              </a:ext>
            </a:extLst>
          </p:cNvPr>
          <p:cNvSpPr txBox="1"/>
          <p:nvPr/>
        </p:nvSpPr>
        <p:spPr>
          <a:xfrm>
            <a:off x="1461837" y="1483371"/>
            <a:ext cx="8981574" cy="278326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</a:pPr>
            <a:r>
              <a:rPr lang="en-US" sz="1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SF, Figure 2</a:t>
            </a:r>
            <a:r>
              <a:rPr lang="en-US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Three-dimensional plot showing the distribution of all normal controls (blue squares), patients with simple neurocognitive psychosis (SNP, red circles) and major neurocognitive psychosis (green triangles) with respect to principal component 1 (PC1), PC3 and PC4, which were extracted from three biomarkers and 8 cognitive tests scores.</a:t>
            </a:r>
          </a:p>
          <a:p>
            <a:pPr>
              <a:lnSpc>
                <a:spcPct val="200000"/>
              </a:lnSpc>
            </a:pPr>
            <a:r>
              <a:rPr lang="en-US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861744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85</TotalTime>
  <Words>1442</Words>
  <Application>Microsoft Office PowerPoint</Application>
  <PresentationFormat>宽屏</PresentationFormat>
  <Paragraphs>284</Paragraphs>
  <Slides>8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6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8</vt:i4>
      </vt:variant>
    </vt:vector>
  </HeadingPairs>
  <TitlesOfParts>
    <vt:vector size="15" baseType="lpstr">
      <vt:lpstr>等线</vt:lpstr>
      <vt:lpstr>Aptos</vt:lpstr>
      <vt:lpstr>Arial</vt:lpstr>
      <vt:lpstr>Calibri</vt:lpstr>
      <vt:lpstr>Calibri Light</vt:lpstr>
      <vt:lpstr>Times New Roman</vt:lpstr>
      <vt:lpstr>Office Theme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haelMaes MichaelMaes</dc:creator>
  <cp:lastModifiedBy>CHEN CHEN</cp:lastModifiedBy>
  <cp:revision>106</cp:revision>
  <dcterms:created xsi:type="dcterms:W3CDTF">2023-11-12T12:56:27Z</dcterms:created>
  <dcterms:modified xsi:type="dcterms:W3CDTF">2024-04-17T06:01:37Z</dcterms:modified>
</cp:coreProperties>
</file>